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5/11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5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44522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orpeleijn et al (2023) Diabetologia DOI 10.1007/s00125-023-06041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Atherogenic lipoproteins in individuals with type 1 diabetes with poor glycaemic control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4DF0D0C-8DF0-F505-5DD8-48AEEF674F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9672" y="836712"/>
            <a:ext cx="5933853" cy="4896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6</cp:revision>
  <dcterms:created xsi:type="dcterms:W3CDTF">2016-06-15T12:53:43Z</dcterms:created>
  <dcterms:modified xsi:type="dcterms:W3CDTF">2023-11-15T08:58:52Z</dcterms:modified>
</cp:coreProperties>
</file>